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8.jpeg" ContentType="image/jpeg"/>
  <Override PartName="/ppt/media/image10.jpeg" ContentType="image/jpeg"/>
  <Override PartName="/ppt/media/image12.jpeg" ContentType="image/jpeg"/>
  <Override PartName="/ppt/media/image7.jpeg" ContentType="image/jpeg"/>
  <Override PartName="/ppt/media/image20.jpeg" ContentType="image/jpeg"/>
  <Override PartName="/ppt/media/image15.jpeg" ContentType="image/jpeg"/>
  <Override PartName="/ppt/media/image19.jpeg" ContentType="image/jpeg"/>
  <Override PartName="/ppt/media/image1.jpeg" ContentType="image/jpeg"/>
  <Override PartName="/ppt/media/image18.jpeg" ContentType="image/jpeg"/>
  <Override PartName="/ppt/media/image17.jpeg" ContentType="image/jpeg"/>
  <Override PartName="/ppt/media/image16.jpeg" ContentType="image/jpeg"/>
  <Override PartName="/ppt/media/image14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EBB64D-2D38-4ED9-A9E2-C3F25362E4A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199B02-2B8A-47E1-84ED-0458957481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F22AE5-1A3A-40CE-90C8-4A3787716BA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CA30D5-B900-4672-91C0-5D232AD9ED6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B6C115-FE6E-42C1-9A0F-49E98B1AA0F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94EF05-809E-4D13-8A20-05FDEEFD63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A8118D-BF2D-4AFA-8BC0-8454EAD226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7E685D-9C7B-45B1-ABA1-7C3589E30A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54B527-2EAE-4A1C-AB27-297DB9D8B4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ACB7A7-4065-4BF4-A83C-1BEFCD35C9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321ADB-A153-4498-8022-F52C5CCB37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EDC147-A457-482D-86CE-66B6BAC168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030DEC0-A7C9-4F62-9AAD-9ACB87BFEBB3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5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jpeg"/><Relationship Id="rId3" Type="http://schemas.openxmlformats.org/officeDocument/2006/relationships/image" Target="../media/image7.jpeg"/><Relationship Id="rId4" Type="http://schemas.openxmlformats.org/officeDocument/2006/relationships/image" Target="../media/image8.jpeg"/><Relationship Id="rId5" Type="http://schemas.openxmlformats.org/officeDocument/2006/relationships/slideLayout" Target="../slideLayouts/slideLayout5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image" Target="../media/image10.jpeg"/><Relationship Id="rId3" Type="http://schemas.openxmlformats.org/officeDocument/2006/relationships/image" Target="../media/image11.jpeg"/><Relationship Id="rId4" Type="http://schemas.openxmlformats.org/officeDocument/2006/relationships/image" Target="../media/image12.jpeg"/><Relationship Id="rId5" Type="http://schemas.openxmlformats.org/officeDocument/2006/relationships/slideLayout" Target="../slideLayouts/slideLayout5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image" Target="../media/image14.jpeg"/><Relationship Id="rId3" Type="http://schemas.openxmlformats.org/officeDocument/2006/relationships/image" Target="../media/image15.jpeg"/><Relationship Id="rId4" Type="http://schemas.openxmlformats.org/officeDocument/2006/relationships/image" Target="../media/image16.jpeg"/><Relationship Id="rId5" Type="http://schemas.openxmlformats.org/officeDocument/2006/relationships/slideLayout" Target="../slideLayouts/slideLayout5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7.jpeg"/><Relationship Id="rId2" Type="http://schemas.openxmlformats.org/officeDocument/2006/relationships/image" Target="../media/image18.jpeg"/><Relationship Id="rId3" Type="http://schemas.openxmlformats.org/officeDocument/2006/relationships/image" Target="../media/image19.jpeg"/><Relationship Id="rId4" Type="http://schemas.openxmlformats.org/officeDocument/2006/relationships/image" Target="../media/image20.jpeg"/><Relationship Id="rId5" Type="http://schemas.openxmlformats.org/officeDocument/2006/relationships/slideLayout" Target="../slideLayouts/slideLayout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0" y="260280"/>
            <a:ext cx="5113440" cy="2952720"/>
          </a:xfrm>
          <a:prstGeom prst="rect">
            <a:avLst/>
          </a:prstGeom>
          <a:blipFill rotWithShape="0">
            <a:blip r:embed="rId1"/>
            <a:srcRect/>
            <a:stretch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0" y="6216480"/>
            <a:ext cx="914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Additional file 6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. Genes up/down regulated in the overview of metabolism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013280" y="260280"/>
            <a:ext cx="5113080" cy="2935440"/>
          </a:xfrm>
          <a:prstGeom prst="rect">
            <a:avLst/>
          </a:prstGeom>
          <a:blipFill rotWithShape="0">
            <a:blip r:embed="rId2"/>
            <a:srcRect/>
            <a:stretch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0" y="3179880"/>
            <a:ext cx="5113440" cy="2935080"/>
          </a:xfrm>
          <a:prstGeom prst="rect">
            <a:avLst/>
          </a:prstGeom>
          <a:blipFill rotWithShape="0">
            <a:blip r:embed="rId3"/>
            <a:srcRect/>
            <a:stretch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014720" y="3170160"/>
            <a:ext cx="5113440" cy="2935440"/>
          </a:xfrm>
          <a:prstGeom prst="rect">
            <a:avLst/>
          </a:prstGeom>
          <a:blipFill rotWithShape="0">
            <a:blip r:embed="rId4"/>
            <a:srcRect/>
            <a:stretch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585240" y="2852640"/>
            <a:ext cx="43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3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8150760" y="2852640"/>
            <a:ext cx="43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6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494880" y="5799240"/>
            <a:ext cx="56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2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8060760" y="5799240"/>
            <a:ext cx="56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4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0" y="193680"/>
            <a:ext cx="5364000" cy="2994120"/>
          </a:xfrm>
          <a:prstGeom prst="rect">
            <a:avLst/>
          </a:prstGeom>
          <a:blipFill rotWithShape="0">
            <a:blip r:embed="rId1"/>
            <a:srcRect/>
            <a:stretch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780000" y="189000"/>
            <a:ext cx="5364000" cy="2993760"/>
          </a:xfrm>
          <a:prstGeom prst="rect">
            <a:avLst/>
          </a:prstGeom>
          <a:blipFill rotWithShape="0">
            <a:blip r:embed="rId2"/>
            <a:srcRect/>
            <a:stretch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0" y="3075120"/>
            <a:ext cx="5364000" cy="2993760"/>
          </a:xfrm>
          <a:prstGeom prst="rect">
            <a:avLst/>
          </a:prstGeom>
          <a:blipFill rotWithShape="0">
            <a:blip r:embed="rId3"/>
            <a:srcRect/>
            <a:stretch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780000" y="3075120"/>
            <a:ext cx="5364000" cy="2993760"/>
          </a:xfrm>
          <a:prstGeom prst="rect">
            <a:avLst/>
          </a:prstGeom>
          <a:blipFill rotWithShape="0">
            <a:blip r:embed="rId4"/>
            <a:srcRect/>
            <a:stretch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296160" y="2643120"/>
            <a:ext cx="43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3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7544520" y="2643120"/>
            <a:ext cx="43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6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206160" y="5659560"/>
            <a:ext cx="56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2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7454160" y="5659560"/>
            <a:ext cx="56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4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0" y="6216480"/>
            <a:ext cx="914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Additional file 6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B. Genes up/down regulated in the JA synthesi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0" y="57240"/>
            <a:ext cx="5305320" cy="3122640"/>
          </a:xfrm>
          <a:prstGeom prst="rect">
            <a:avLst/>
          </a:prstGeom>
          <a:blipFill rotWithShape="0">
            <a:blip r:embed="rId1"/>
            <a:srcRect/>
            <a:stretch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0" y="6446880"/>
            <a:ext cx="914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Additional file 6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C. Genes up/down regulated in the overview of regulation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4379760" y="57240"/>
            <a:ext cx="5305680" cy="3122640"/>
          </a:xfrm>
          <a:prstGeom prst="rect">
            <a:avLst/>
          </a:prstGeom>
          <a:blipFill rotWithShape="0">
            <a:blip r:embed="rId2"/>
            <a:srcRect/>
            <a:stretch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0" y="3178080"/>
            <a:ext cx="5305320" cy="3122640"/>
          </a:xfrm>
          <a:prstGeom prst="rect">
            <a:avLst/>
          </a:prstGeom>
          <a:blipFill rotWithShape="0">
            <a:blip r:embed="rId3"/>
            <a:srcRect/>
            <a:stretch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4379760" y="3178080"/>
            <a:ext cx="5305680" cy="3122640"/>
          </a:xfrm>
          <a:prstGeom prst="rect">
            <a:avLst/>
          </a:prstGeom>
          <a:blipFill rotWithShape="0">
            <a:blip r:embed="rId4"/>
            <a:srcRect/>
            <a:stretch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872520" y="2781360"/>
            <a:ext cx="43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3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8347680" y="2781360"/>
            <a:ext cx="43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6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782160" y="5942160"/>
            <a:ext cx="56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2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8257320" y="5942160"/>
            <a:ext cx="56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4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440" y="555480"/>
            <a:ext cx="5112000" cy="2892600"/>
          </a:xfrm>
          <a:prstGeom prst="rect">
            <a:avLst/>
          </a:prstGeom>
          <a:blipFill rotWithShape="0">
            <a:blip r:embed="rId1"/>
            <a:srcRect/>
            <a:stretch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0" y="6302520"/>
            <a:ext cx="914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Additional file 6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D. Genes up/down regulated in the transcription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4067280" y="555480"/>
            <a:ext cx="5111640" cy="2892600"/>
          </a:xfrm>
          <a:prstGeom prst="rect">
            <a:avLst/>
          </a:prstGeom>
          <a:blipFill rotWithShape="0">
            <a:blip r:embed="rId2"/>
            <a:srcRect/>
            <a:stretch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440" y="3232080"/>
            <a:ext cx="5112000" cy="2892600"/>
          </a:xfrm>
          <a:prstGeom prst="rect">
            <a:avLst/>
          </a:prstGeom>
          <a:blipFill rotWithShape="0">
            <a:blip r:embed="rId3"/>
            <a:srcRect/>
            <a:stretch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067280" y="3232080"/>
            <a:ext cx="5111640" cy="2892600"/>
          </a:xfrm>
          <a:prstGeom prst="rect">
            <a:avLst/>
          </a:prstGeom>
          <a:blipFill rotWithShape="0">
            <a:blip r:embed="rId4"/>
            <a:srcRect/>
            <a:stretch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3656520" y="2871720"/>
            <a:ext cx="43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3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8708040" y="2871720"/>
            <a:ext cx="43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6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566520" y="5745240"/>
            <a:ext cx="56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2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8617680" y="5745240"/>
            <a:ext cx="56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4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1403280" y="-27000"/>
            <a:ext cx="3527640" cy="3075120"/>
          </a:xfrm>
          <a:prstGeom prst="rect">
            <a:avLst/>
          </a:prstGeom>
          <a:blipFill rotWithShape="0">
            <a:blip r:embed="rId1"/>
            <a:srcRect/>
            <a:stretch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0" y="6216480"/>
            <a:ext cx="914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Additional file 6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E. Genes up/down regulated in the RNA-protein synthesi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4572000" y="-27000"/>
            <a:ext cx="3527280" cy="3075120"/>
          </a:xfrm>
          <a:prstGeom prst="rect">
            <a:avLst/>
          </a:prstGeom>
          <a:blipFill rotWithShape="0">
            <a:blip r:embed="rId2"/>
            <a:srcRect/>
            <a:stretch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1403280" y="3024360"/>
            <a:ext cx="3527640" cy="3074760"/>
          </a:xfrm>
          <a:prstGeom prst="rect">
            <a:avLst/>
          </a:prstGeom>
          <a:blipFill rotWithShape="0">
            <a:blip r:embed="rId3"/>
            <a:srcRect/>
            <a:stretch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4572000" y="3024360"/>
            <a:ext cx="3527280" cy="3074760"/>
          </a:xfrm>
          <a:prstGeom prst="rect">
            <a:avLst/>
          </a:prstGeom>
          <a:blipFill rotWithShape="0">
            <a:blip r:embed="rId4"/>
            <a:srcRect/>
            <a:stretch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4016880" y="2637000"/>
            <a:ext cx="43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3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7688880" y="2637000"/>
            <a:ext cx="43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6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3926880" y="5726160"/>
            <a:ext cx="56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2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7598520" y="5726160"/>
            <a:ext cx="56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4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09T08:42:58Z</dcterms:created>
  <dc:creator>User</dc:creator>
  <dc:description/>
  <dc:language>en-US</dc:language>
  <cp:lastModifiedBy>User</cp:lastModifiedBy>
  <dcterms:modified xsi:type="dcterms:W3CDTF">2010-03-09T10:55:06Z</dcterms:modified>
  <cp:revision>9</cp:revision>
  <dc:subject/>
  <dc:title>相册</dc:title>
</cp:coreProperties>
</file>